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258" r:id="rId2"/>
    <p:sldId id="259" r:id="rId3"/>
    <p:sldId id="260"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955"/>
    <p:restoredTop sz="94599"/>
  </p:normalViewPr>
  <p:slideViewPr>
    <p:cSldViewPr snapToGrid="0">
      <p:cViewPr varScale="1">
        <p:scale>
          <a:sx n="82" d="100"/>
          <a:sy n="82" d="100"/>
        </p:scale>
        <p:origin x="176" y="68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29715B5-85CF-5741-9E5C-29C28A169B7C}" type="datetimeFigureOut">
              <a:rPr lang="en-US" smtClean="0"/>
              <a:t>3/3/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E85D944-3A8E-7948-925B-B3107B0C3EA8}" type="slidenum">
              <a:rPr lang="en-US" smtClean="0"/>
              <a:t>‹#›</a:t>
            </a:fld>
            <a:endParaRPr lang="en-US"/>
          </a:p>
        </p:txBody>
      </p:sp>
    </p:spTree>
    <p:extLst>
      <p:ext uri="{BB962C8B-B14F-4D97-AF65-F5344CB8AC3E}">
        <p14:creationId xmlns:p14="http://schemas.microsoft.com/office/powerpoint/2010/main" val="3583659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85D944-3A8E-7948-925B-B3107B0C3EA8}" type="slidenum">
              <a:rPr lang="en-US" smtClean="0"/>
              <a:t>2</a:t>
            </a:fld>
            <a:endParaRPr lang="en-US"/>
          </a:p>
        </p:txBody>
      </p:sp>
    </p:spTree>
    <p:extLst>
      <p:ext uri="{BB962C8B-B14F-4D97-AF65-F5344CB8AC3E}">
        <p14:creationId xmlns:p14="http://schemas.microsoft.com/office/powerpoint/2010/main" val="23680068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94DB2D-3571-317E-C0E9-1AF3436D4BC9}"/>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99E1DBEA-9BF4-C6A4-672C-FBAD1230A0E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C8146B3A-17CF-F662-1415-5C182D1265F1}"/>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5" name="Footer Placeholder 4">
            <a:extLst>
              <a:ext uri="{FF2B5EF4-FFF2-40B4-BE49-F238E27FC236}">
                <a16:creationId xmlns:a16="http://schemas.microsoft.com/office/drawing/2014/main" id="{AE7C17D1-C135-AE97-39F5-79C78F3B9B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04E030-267E-80F2-8C0B-22FAF4C9DFDE}"/>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21141079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DAF3D3-E07C-ED3A-22C1-1987EA3E72F8}"/>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EAA22DC2-8EE5-A886-B751-384B7B4C7DE1}"/>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F5FDF070-DA55-CF24-8567-2221C97E87A2}"/>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5" name="Footer Placeholder 4">
            <a:extLst>
              <a:ext uri="{FF2B5EF4-FFF2-40B4-BE49-F238E27FC236}">
                <a16:creationId xmlns:a16="http://schemas.microsoft.com/office/drawing/2014/main" id="{E4E89C09-6727-8CD4-526D-BF351C22C6E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4D4900A-8E47-88A0-3FC4-1BC072A038E2}"/>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41320769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64FBC33-BE21-E52C-EC47-E508C7FD9180}"/>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7402D9B3-1A68-10A4-3B4F-080AEB7DB2CA}"/>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8300AE9D-E10D-42B2-E1AC-488239DB2443}"/>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5" name="Footer Placeholder 4">
            <a:extLst>
              <a:ext uri="{FF2B5EF4-FFF2-40B4-BE49-F238E27FC236}">
                <a16:creationId xmlns:a16="http://schemas.microsoft.com/office/drawing/2014/main" id="{F4C8F9B2-E174-5669-575F-236EA72CB5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A16EAE-6DD0-B0F1-55E4-8105CDFDB145}"/>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4347509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43B307-187E-AA56-F932-9A39819762A8}"/>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DB08F369-2E9C-430D-EAF1-64BCB0177808}"/>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0A46AD28-04E8-0A91-8AB0-1705C3F2DDED}"/>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5" name="Footer Placeholder 4">
            <a:extLst>
              <a:ext uri="{FF2B5EF4-FFF2-40B4-BE49-F238E27FC236}">
                <a16:creationId xmlns:a16="http://schemas.microsoft.com/office/drawing/2014/main" id="{A4CC98C3-8350-F3B0-54F8-E972257D28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63BDD8-D890-1C18-316D-555DF3F7E854}"/>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8554839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BDCA1E-60BD-7F34-202E-4B4CCFABB7FB}"/>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D6AB3E43-0281-32BE-3772-EDED69DF3E2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E13B4787-A09A-28E6-26FD-E041EC252D57}"/>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5" name="Footer Placeholder 4">
            <a:extLst>
              <a:ext uri="{FF2B5EF4-FFF2-40B4-BE49-F238E27FC236}">
                <a16:creationId xmlns:a16="http://schemas.microsoft.com/office/drawing/2014/main" id="{1FAB7C6D-1E00-35F9-B4B9-B851BF0375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14708F-A65C-51A5-29F1-2587AA0C5AD8}"/>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22524536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36F7F1-B7E1-A2E3-1A5A-CDED1AA051DF}"/>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1D091F45-33F5-B92C-7A93-F13802541CC4}"/>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3B3857ED-5C71-64EF-BB80-5FA42AEC8591}"/>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4612B061-6534-05FA-2176-C35AA6289FC2}"/>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6" name="Footer Placeholder 5">
            <a:extLst>
              <a:ext uri="{FF2B5EF4-FFF2-40B4-BE49-F238E27FC236}">
                <a16:creationId xmlns:a16="http://schemas.microsoft.com/office/drawing/2014/main" id="{FF4FD689-9F58-8816-E246-8C88A677F9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22AFFB-7C76-3041-7D39-91B229EBC19F}"/>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9668901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46D89F-5177-85AA-BB52-7B594AF7DC47}"/>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EA01168C-E7C5-8F78-B182-D24B59957D1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CEFE0305-AE13-3CDF-A497-AF4B2DC74E53}"/>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DADDE7DB-7285-0609-611F-6D11E46DC32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7DDE847F-6B39-3283-21FA-4975E30D42A7}"/>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716FF3A2-9EE4-A00A-AA83-F838934083F9}"/>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8" name="Footer Placeholder 7">
            <a:extLst>
              <a:ext uri="{FF2B5EF4-FFF2-40B4-BE49-F238E27FC236}">
                <a16:creationId xmlns:a16="http://schemas.microsoft.com/office/drawing/2014/main" id="{7955368D-CA7C-AECB-D44D-1D8F0712EFF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248557B-70C2-2496-4182-D5576CB5364B}"/>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7065956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C83A75-5129-CBBE-FC6B-38C97D74FE7F}"/>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1BB936E4-F054-5C16-899F-067942823BB7}"/>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4" name="Footer Placeholder 3">
            <a:extLst>
              <a:ext uri="{FF2B5EF4-FFF2-40B4-BE49-F238E27FC236}">
                <a16:creationId xmlns:a16="http://schemas.microsoft.com/office/drawing/2014/main" id="{FD1ADF67-1C1E-6648-06E4-3FC1C034E76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A980E47-BE80-18E6-F60D-CDA607D8E3B6}"/>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7920802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7C0FD82-B652-EB42-77C3-2DBD454321B8}"/>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3" name="Footer Placeholder 2">
            <a:extLst>
              <a:ext uri="{FF2B5EF4-FFF2-40B4-BE49-F238E27FC236}">
                <a16:creationId xmlns:a16="http://schemas.microsoft.com/office/drawing/2014/main" id="{998E03D2-1E4C-B94B-73CB-109572BDDA1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E529039-EC91-2657-1E19-57950525975E}"/>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0507103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2420D3-5F26-682A-B770-D675F4A29F30}"/>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17A12C1C-D5C0-1D6D-757D-335B84252BB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CAAF274A-94BB-17E1-1FB9-8E4706E878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E12CFCB-4B3D-1889-B32B-51218BEDB518}"/>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6" name="Footer Placeholder 5">
            <a:extLst>
              <a:ext uri="{FF2B5EF4-FFF2-40B4-BE49-F238E27FC236}">
                <a16:creationId xmlns:a16="http://schemas.microsoft.com/office/drawing/2014/main" id="{BC93DD79-12E5-7424-0C0E-6C696DDF1C0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E2363B3-5037-4E1B-93AD-A279E929DB27}"/>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5631190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DE2693-6624-648F-AF9D-2C56617B55A0}"/>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C19CC03C-672A-7CC7-3469-81D28253441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0ECC645-4E7B-7D5E-33F2-A85150BF02A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6E311B1C-83A5-25EA-7C43-0CF7BED203C5}"/>
              </a:ext>
            </a:extLst>
          </p:cNvPr>
          <p:cNvSpPr>
            <a:spLocks noGrp="1"/>
          </p:cNvSpPr>
          <p:nvPr>
            <p:ph type="dt" sz="half" idx="10"/>
          </p:nvPr>
        </p:nvSpPr>
        <p:spPr/>
        <p:txBody>
          <a:bodyPr/>
          <a:lstStyle/>
          <a:p>
            <a:fld id="{191F5A98-1823-8F4C-B374-EF8284E59033}" type="datetimeFigureOut">
              <a:rPr lang="en-US" smtClean="0"/>
              <a:t>3/3/25</a:t>
            </a:fld>
            <a:endParaRPr lang="en-US"/>
          </a:p>
        </p:txBody>
      </p:sp>
      <p:sp>
        <p:nvSpPr>
          <p:cNvPr id="6" name="Footer Placeholder 5">
            <a:extLst>
              <a:ext uri="{FF2B5EF4-FFF2-40B4-BE49-F238E27FC236}">
                <a16:creationId xmlns:a16="http://schemas.microsoft.com/office/drawing/2014/main" id="{2603A56D-5E12-AC3E-CA40-124204208C6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0BE8D58-BB0E-0A98-3BAD-7A15BBF931A9}"/>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16015221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FAD7957-4FCA-570E-24F3-8E81BD73026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B5894B01-E04D-C7E2-AA38-69FAA840FD4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0C5E7C40-E84D-E2E2-DAB0-FA5F8D6F1D2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191F5A98-1823-8F4C-B374-EF8284E59033}" type="datetimeFigureOut">
              <a:rPr lang="en-US" smtClean="0"/>
              <a:t>3/3/25</a:t>
            </a:fld>
            <a:endParaRPr lang="en-US"/>
          </a:p>
        </p:txBody>
      </p:sp>
      <p:sp>
        <p:nvSpPr>
          <p:cNvPr id="5" name="Footer Placeholder 4">
            <a:extLst>
              <a:ext uri="{FF2B5EF4-FFF2-40B4-BE49-F238E27FC236}">
                <a16:creationId xmlns:a16="http://schemas.microsoft.com/office/drawing/2014/main" id="{A9895B9A-8F5D-4454-A6B1-760D6B2D707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81360C5D-7A57-98BD-D4CF-7A97486DC08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50AFBC9-1B93-154E-A474-60B4828E7B21}" type="slidenum">
              <a:rPr lang="en-US" smtClean="0"/>
              <a:t>‹#›</a:t>
            </a:fld>
            <a:endParaRPr lang="en-US"/>
          </a:p>
        </p:txBody>
      </p:sp>
    </p:spTree>
    <p:extLst>
      <p:ext uri="{BB962C8B-B14F-4D97-AF65-F5344CB8AC3E}">
        <p14:creationId xmlns:p14="http://schemas.microsoft.com/office/powerpoint/2010/main" val="14039997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1FD55CB-120D-DA8A-C906-DA69CE5A19EC}"/>
              </a:ext>
            </a:extLst>
          </p:cNvPr>
          <p:cNvSpPr txBox="1"/>
          <p:nvPr/>
        </p:nvSpPr>
        <p:spPr>
          <a:xfrm>
            <a:off x="2901373" y="4997450"/>
            <a:ext cx="6076373" cy="738664"/>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Table S1: Root assay quantifications. Proportion of </a:t>
            </a:r>
            <a:r>
              <a:rPr lang="en-US" sz="1400" dirty="0" err="1">
                <a:latin typeface="Times New Roman" panose="02020603050405020304" pitchFamily="18" charset="0"/>
                <a:cs typeface="Times New Roman" panose="02020603050405020304" pitchFamily="18" charset="0"/>
              </a:rPr>
              <a:t>Endogonales</a:t>
            </a:r>
            <a:r>
              <a:rPr lang="en-US" sz="1400" dirty="0">
                <a:latin typeface="Times New Roman" panose="02020603050405020304" pitchFamily="18" charset="0"/>
                <a:cs typeface="Times New Roman" panose="02020603050405020304" pitchFamily="18" charset="0"/>
              </a:rPr>
              <a:t> 18S rRNA sequences, root colonisation by FRE and G-AMF and the portion of AMF colonisation by FRE. </a:t>
            </a:r>
          </a:p>
        </p:txBody>
      </p:sp>
      <p:pic>
        <p:nvPicPr>
          <p:cNvPr id="4" name="Picture 3" descr="A table with numbers and text&#10;&#10;Description automatically generated">
            <a:extLst>
              <a:ext uri="{FF2B5EF4-FFF2-40B4-BE49-F238E27FC236}">
                <a16:creationId xmlns:a16="http://schemas.microsoft.com/office/drawing/2014/main" id="{6F27EE3F-9691-CBD5-5643-BFA91862A5AB}"/>
              </a:ext>
            </a:extLst>
          </p:cNvPr>
          <p:cNvPicPr>
            <a:picLocks noChangeAspect="1"/>
          </p:cNvPicPr>
          <p:nvPr/>
        </p:nvPicPr>
        <p:blipFill>
          <a:blip r:embed="rId2"/>
          <a:stretch>
            <a:fillRect/>
          </a:stretch>
        </p:blipFill>
        <p:spPr>
          <a:xfrm>
            <a:off x="2984500" y="1860550"/>
            <a:ext cx="6223000" cy="3136900"/>
          </a:xfrm>
          <a:prstGeom prst="rect">
            <a:avLst/>
          </a:prstGeom>
        </p:spPr>
      </p:pic>
    </p:spTree>
    <p:extLst>
      <p:ext uri="{BB962C8B-B14F-4D97-AF65-F5344CB8AC3E}">
        <p14:creationId xmlns:p14="http://schemas.microsoft.com/office/powerpoint/2010/main" val="37665598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F466441-6374-6B28-CFC8-1DFC5E5F6204}"/>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356FC007-8519-3571-E913-90E7AEF628D3}"/>
              </a:ext>
            </a:extLst>
          </p:cNvPr>
          <p:cNvSpPr txBox="1"/>
          <p:nvPr/>
        </p:nvSpPr>
        <p:spPr>
          <a:xfrm>
            <a:off x="2984500" y="4931665"/>
            <a:ext cx="6076373" cy="738664"/>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Table S2: Following a BLAST search of the FRE4583 18S rRNA operon, multiple bins were found in close proximity in the assembly graph (Fig. S2). This table shows the bins key characteristics as computed by BUSCO. </a:t>
            </a:r>
          </a:p>
        </p:txBody>
      </p:sp>
      <p:pic>
        <p:nvPicPr>
          <p:cNvPr id="2" name="Picture 1" descr="A table of numbers and letters&#10;&#10;Description automatically generated">
            <a:extLst>
              <a:ext uri="{FF2B5EF4-FFF2-40B4-BE49-F238E27FC236}">
                <a16:creationId xmlns:a16="http://schemas.microsoft.com/office/drawing/2014/main" id="{5E364C9B-FE0C-CDBF-018F-595E98E73FCE}"/>
              </a:ext>
            </a:extLst>
          </p:cNvPr>
          <p:cNvPicPr>
            <a:picLocks noChangeAspect="1"/>
          </p:cNvPicPr>
          <p:nvPr/>
        </p:nvPicPr>
        <p:blipFill>
          <a:blip r:embed="rId3"/>
          <a:stretch>
            <a:fillRect/>
          </a:stretch>
        </p:blipFill>
        <p:spPr>
          <a:xfrm>
            <a:off x="2933700" y="1905000"/>
            <a:ext cx="6324600" cy="3048000"/>
          </a:xfrm>
          <a:prstGeom prst="rect">
            <a:avLst/>
          </a:prstGeom>
        </p:spPr>
      </p:pic>
    </p:spTree>
    <p:extLst>
      <p:ext uri="{BB962C8B-B14F-4D97-AF65-F5344CB8AC3E}">
        <p14:creationId xmlns:p14="http://schemas.microsoft.com/office/powerpoint/2010/main" val="25469831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649110B-D573-FDB9-EED3-FD090F6EAB33}"/>
              </a:ext>
            </a:extLst>
          </p:cNvPr>
          <p:cNvSpPr txBox="1"/>
          <p:nvPr/>
        </p:nvSpPr>
        <p:spPr>
          <a:xfrm>
            <a:off x="178130" y="988046"/>
            <a:ext cx="627633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able S3: Reference database of fungal genomes constructed from JGI </a:t>
            </a:r>
            <a:r>
              <a:rPr lang="en-US" sz="1400" dirty="0" err="1">
                <a:latin typeface="Times New Roman" panose="02020603050405020304" pitchFamily="18" charset="0"/>
                <a:cs typeface="Times New Roman" panose="02020603050405020304" pitchFamily="18" charset="0"/>
              </a:rPr>
              <a:t>MycoCosm</a:t>
            </a:r>
            <a:r>
              <a:rPr lang="en-US" sz="1400" dirty="0">
                <a:latin typeface="Times New Roman" panose="02020603050405020304" pitchFamily="18" charset="0"/>
                <a:cs typeface="Times New Roman" panose="02020603050405020304" pitchFamily="18" charset="0"/>
              </a:rPr>
              <a:t>.  </a:t>
            </a:r>
          </a:p>
        </p:txBody>
      </p:sp>
      <p:sp>
        <p:nvSpPr>
          <p:cNvPr id="2" name="TextBox 1">
            <a:extLst>
              <a:ext uri="{FF2B5EF4-FFF2-40B4-BE49-F238E27FC236}">
                <a16:creationId xmlns:a16="http://schemas.microsoft.com/office/drawing/2014/main" id="{B2D940F0-A007-3A5E-779E-38FE18A79F8C}"/>
              </a:ext>
            </a:extLst>
          </p:cNvPr>
          <p:cNvSpPr txBox="1"/>
          <p:nvPr/>
        </p:nvSpPr>
        <p:spPr>
          <a:xfrm>
            <a:off x="178130" y="249382"/>
            <a:ext cx="344196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Excel File ‘Supplementary_File_1’</a:t>
            </a:r>
          </a:p>
        </p:txBody>
      </p:sp>
      <p:sp>
        <p:nvSpPr>
          <p:cNvPr id="7" name="TextBox 6">
            <a:extLst>
              <a:ext uri="{FF2B5EF4-FFF2-40B4-BE49-F238E27FC236}">
                <a16:creationId xmlns:a16="http://schemas.microsoft.com/office/drawing/2014/main" id="{4E173AE9-C593-4F1F-28E4-8CA3AF83E743}"/>
              </a:ext>
            </a:extLst>
          </p:cNvPr>
          <p:cNvSpPr txBox="1"/>
          <p:nvPr/>
        </p:nvSpPr>
        <p:spPr>
          <a:xfrm>
            <a:off x="178130" y="1326600"/>
            <a:ext cx="7585987" cy="523220"/>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able S4: Counts of CAZyme families annotated in the MAG, mycorrhizal and saprotrophic genomes. </a:t>
            </a:r>
          </a:p>
          <a:p>
            <a:endParaRPr lang="en-US" sz="1400"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E4E60541-852C-2904-F0A6-3CC598FDC39F}"/>
              </a:ext>
            </a:extLst>
          </p:cNvPr>
          <p:cNvSpPr txBox="1"/>
          <p:nvPr/>
        </p:nvSpPr>
        <p:spPr>
          <a:xfrm>
            <a:off x="178129" y="1665155"/>
            <a:ext cx="9091207" cy="738664"/>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able S5: Counts of EC annotated in the MAG and G-AMF genomes, including key Missing Glomeromycotan Core Genes.</a:t>
            </a:r>
          </a:p>
          <a:p>
            <a:endParaRPr lang="en-US" sz="1400" dirty="0">
              <a:latin typeface="Times New Roman" panose="02020603050405020304" pitchFamily="18" charset="0"/>
              <a:cs typeface="Times New Roman" panose="02020603050405020304" pitchFamily="18" charset="0"/>
            </a:endParaRPr>
          </a:p>
          <a:p>
            <a:endParaRPr 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726742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957</TotalTime>
  <Words>132</Words>
  <Application>Microsoft Macintosh PowerPoint</Application>
  <PresentationFormat>Widescreen</PresentationFormat>
  <Paragraphs>7</Paragraphs>
  <Slides>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ptos</vt:lpstr>
      <vt:lpstr>Aptos Display</vt:lpstr>
      <vt:lpstr>Arial</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OLE, JOSH (PGR)</dc:creator>
  <cp:lastModifiedBy>COLE, JOSH (PGR)</cp:lastModifiedBy>
  <cp:revision>8</cp:revision>
  <dcterms:created xsi:type="dcterms:W3CDTF">2024-11-10T23:33:24Z</dcterms:created>
  <dcterms:modified xsi:type="dcterms:W3CDTF">2025-03-03T21:01:41Z</dcterms:modified>
</cp:coreProperties>
</file>